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3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1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50702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11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7A7145D-47B7-5C3A-61BE-3AF92FFDDB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670" y="1772816"/>
            <a:ext cx="8226660" cy="3092729"/>
          </a:xfrm>
          <a:prstGeom prst="rect">
            <a:avLst/>
          </a:prstGeom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bach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330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44624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Illustration of Geoffrey Rose's prevention paradox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448706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ckenbach et al (2024) Diabetologia DOI 10.1007/s00125-024-06330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. Figure designed using resources from Flaticon.com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44624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Population-based, low-agency policies for the prevention and reduction of the burden of type 2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856E140-52BF-B5A1-2B69-35F577064BE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7071" y="764704"/>
            <a:ext cx="5529859" cy="5040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9221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On-screen Show (4:3)</PresentationFormat>
  <Paragraphs>1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4-11-20T13:42:18Z</dcterms:modified>
</cp:coreProperties>
</file>